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1952" r:id="rId2"/>
    <p:sldId id="1950" r:id="rId3"/>
    <p:sldId id="1951" r:id="rId4"/>
    <p:sldId id="1754" r:id="rId5"/>
    <p:sldId id="1949" r:id="rId6"/>
    <p:sldId id="1953" r:id="rId7"/>
    <p:sldId id="1948" r:id="rId8"/>
  </p:sldIdLst>
  <p:sldSz cx="12192000" cy="6858000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AC58FD2E-3E18-1D41-B675-528667A083DE}">
          <p14:sldIdLst>
            <p14:sldId id="1952"/>
            <p14:sldId id="1950"/>
            <p14:sldId id="1951"/>
            <p14:sldId id="1754"/>
            <p14:sldId id="1949"/>
            <p14:sldId id="1953"/>
            <p14:sldId id="1948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1CBF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233"/>
    <p:restoredTop sz="96197"/>
  </p:normalViewPr>
  <p:slideViewPr>
    <p:cSldViewPr snapToGrid="0">
      <p:cViewPr>
        <p:scale>
          <a:sx n="110" d="100"/>
          <a:sy n="110" d="100"/>
        </p:scale>
        <p:origin x="-1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59081D59-65C0-E040-B191-E2A6138E4EC3}" type="datetimeFigureOut">
              <a:rPr lang="en-US" smtClean="0"/>
              <a:t>7/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9138" y="1163638"/>
            <a:ext cx="5584825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80004"/>
            <a:ext cx="5618480" cy="3665458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9BE04317-4798-B349-9678-6115E50A6D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727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7F9A9-1DBE-7B32-1C32-797001CB08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A0BCF1-43C2-9BB4-96AE-3A2DD81C57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2DE5C1-D449-D6C3-497D-CB30B0CD44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3EB45-6785-7844-A33B-185BE6906A27}" type="datetimeFigureOut">
              <a:rPr lang="en-US" smtClean="0"/>
              <a:t>7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B6AD4A-42D3-738A-40D7-A75BD3BEB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456E0A-D1D2-5B4A-0288-B74F44FAC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73201-9282-7D41-ABE0-C2DEBA30C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477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260FBD-D255-4A67-58D0-B2EF9B50B6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9C0250-0A30-3B78-EE09-F63C47B9F4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861E7D-3DC7-FBA8-1B1A-623F5517E8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3EB45-6785-7844-A33B-185BE6906A27}" type="datetimeFigureOut">
              <a:rPr lang="en-US" smtClean="0"/>
              <a:t>7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B77425-DDFA-3613-69F1-A441954963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B6A807-D5FA-BCD8-39ED-A5A173C27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73201-9282-7D41-ABE0-C2DEBA30C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960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603D7C3-5CA0-07FF-5276-2DD10CF6B7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FD97741-3B5C-F06E-F183-A1F33E7136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530A00-78B4-3EF2-3B91-01D38EBC15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3EB45-6785-7844-A33B-185BE6906A27}" type="datetimeFigureOut">
              <a:rPr lang="en-US" smtClean="0"/>
              <a:t>7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522165-6C00-5079-BF45-8D554E5155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301ED1-5F02-9243-8A88-D03CF10A02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73201-9282-7D41-ABE0-C2DEBA30C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055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40ED9E-F308-010B-9E82-D5DCBD8712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F66FF4-5C94-5331-EB76-B7297B6678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0A5161-221F-6D4B-B0CD-22BE68EB49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3EB45-6785-7844-A33B-185BE6906A27}" type="datetimeFigureOut">
              <a:rPr lang="en-US" smtClean="0"/>
              <a:t>7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BFA76B-BA79-FFFF-72BB-89947A087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2BC8F9-00D7-F1DF-98E3-DED44EB31B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73201-9282-7D41-ABE0-C2DEBA30C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540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B8CBD2-11CB-CD7C-D993-FA54FF68CF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8FBE16-B07F-6D0C-7E9F-3D0CD1ED8F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E918E0-7720-33A1-35F9-EE27ED0C9D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3EB45-6785-7844-A33B-185BE6906A27}" type="datetimeFigureOut">
              <a:rPr lang="en-US" smtClean="0"/>
              <a:t>7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2D9D50-8149-AEC6-020F-0054AD6B4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50EF49-9B25-9470-7860-C4AF030C3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73201-9282-7D41-ABE0-C2DEBA30C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915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C57EB7-07D6-B412-A9A8-9074BDAB29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D309E2-19F6-591B-4A5B-E8623B0D97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1ED8C7-1CE7-AB10-0561-2A5226FBFA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2A067D-C8D6-0226-042C-DB78114EE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3EB45-6785-7844-A33B-185BE6906A27}" type="datetimeFigureOut">
              <a:rPr lang="en-US" smtClean="0"/>
              <a:t>7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30B9A3-8069-31FE-146A-0D02A81BA9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0DF9D7-99EB-F1CD-13CB-FC2EFC1A0B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73201-9282-7D41-ABE0-C2DEBA30C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278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55A11E-DBBF-29D3-A592-FDA86BFA3C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6B1621-9591-01B6-6D85-6A3F1B35EF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F32152-58D7-EFBB-9E76-E1804FB42B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18EF43F-891E-097F-1189-3C96650AD5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3379599-E388-070B-E7FB-8A480C059A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4C0AEF4-0E1F-C904-3F16-9B9865727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3EB45-6785-7844-A33B-185BE6906A27}" type="datetimeFigureOut">
              <a:rPr lang="en-US" smtClean="0"/>
              <a:t>7/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635DB56-1862-3F23-DC8F-392F90643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2C9719D-1574-122C-FBA9-C48F759F7A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73201-9282-7D41-ABE0-C2DEBA30C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5009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BE653F-7313-9955-47FC-AEAD727409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8D5C43F-323A-10A5-2CF4-254D738FBC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3EB45-6785-7844-A33B-185BE6906A27}" type="datetimeFigureOut">
              <a:rPr lang="en-US" smtClean="0"/>
              <a:t>7/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823F56-D9D2-933F-D305-B2E3A601DD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4077182-A343-7F90-F24B-95DA73013A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73201-9282-7D41-ABE0-C2DEBA30C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169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7B0D7C2-394C-388E-276B-F9CD79BD5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3EB45-6785-7844-A33B-185BE6906A27}" type="datetimeFigureOut">
              <a:rPr lang="en-US" smtClean="0"/>
              <a:t>7/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126379C-4027-E370-3A43-ACDF925B57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BF8661D-3E1F-BEDA-2DE1-AFB38A5CB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73201-9282-7D41-ABE0-C2DEBA30C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773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388AEB-7CFC-FAB2-6A10-D16C4347FE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B331E7-CF8F-120B-FB0B-CC00885975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5DCCBB-4A43-93B5-52FF-39C6FBBE3A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B52B0F-2AD4-1D88-7182-C24F73BE2E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3EB45-6785-7844-A33B-185BE6906A27}" type="datetimeFigureOut">
              <a:rPr lang="en-US" smtClean="0"/>
              <a:t>7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D2A555-DE1E-18DD-B8A6-225078362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4ADE93-68EA-B4BE-08B9-444D820BB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73201-9282-7D41-ABE0-C2DEBA30C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894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D51047-5189-7735-9471-8440390B66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B292940-4848-790A-5970-7019201BD9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332832-40A5-104D-2969-48E01F3F60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2739B0-8332-054A-289F-C351AE546A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3EB45-6785-7844-A33B-185BE6906A27}" type="datetimeFigureOut">
              <a:rPr lang="en-US" smtClean="0"/>
              <a:t>7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721ABE-F77E-5781-CD1C-E0FC7EEC9E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E7DEE1-643F-B7D1-C799-5B36C7A614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73201-9282-7D41-ABE0-C2DEBA30C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376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18E3CD3-F666-A2B3-05F3-91D5E9D84A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42B521-B333-3688-EFC6-8C8F464903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0710CD-6311-2F47-E283-3A48F63424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03EB45-6785-7844-A33B-185BE6906A27}" type="datetimeFigureOut">
              <a:rPr lang="en-US" smtClean="0"/>
              <a:t>7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CE67E8-D8BF-CCAF-88CE-AA63C97184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BC833C-06C4-C70E-0A04-AA87207BD8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473201-9282-7D41-ABE0-C2DEBA30C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4479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FEC1DDFF-BBE1-056A-7DA5-3BCE2EEDC2AF}"/>
              </a:ext>
            </a:extLst>
          </p:cNvPr>
          <p:cNvSpPr txBox="1"/>
          <p:nvPr/>
        </p:nvSpPr>
        <p:spPr>
          <a:xfrm>
            <a:off x="1441603" y="4538113"/>
            <a:ext cx="930879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1. 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PRR7 protein abundance under 12 h light 22°C/12 h dark 15°C cycles. </a:t>
            </a:r>
          </a:p>
          <a:p>
            <a:r>
              <a:rPr lang="en-US" sz="1100" i="1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PRR7pro::FLAG-PRR7-GFP (F7G) </a:t>
            </a:r>
            <a:r>
              <a:rPr lang="en-US" sz="1100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and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PRR7pro::FLAG-PRR7-GFP/hos15-2 </a:t>
            </a:r>
            <a:r>
              <a:rPr lang="en-US" sz="1100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(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F7Ghos15-2)</a:t>
            </a:r>
            <a:r>
              <a:rPr lang="en-US" sz="1100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seedlings were grown in a 12 h light/12 h dark (12L/12D) cycle at 22°C for 11 d and transferred to 12 h light 22 °C /12 h dark 15 °C. Seedlings were collected 3 d after transfer at the indicated time points (h). The line graph shows PRR7-GFP protein levels normalized to ADK (n=3); left panel shows representative immunoblots. White- and black-filled rectangles represent light and dark periods, respectively. Statistical analysis was performed using a paired two-tailed Welch’s t-test for each time point. Asterisks indicate significant differences (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&lt; 0.05)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 descr="A close-up of a test results&#10;&#10;Description automatically generated">
            <a:extLst>
              <a:ext uri="{FF2B5EF4-FFF2-40B4-BE49-F238E27FC236}">
                <a16:creationId xmlns:a16="http://schemas.microsoft.com/office/drawing/2014/main" id="{41273649-F1AC-630B-F3A8-719E4EA4A3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7089" y="1745485"/>
            <a:ext cx="4559300" cy="2032000"/>
          </a:xfrm>
          <a:prstGeom prst="rect">
            <a:avLst/>
          </a:prstGeom>
        </p:spPr>
      </p:pic>
      <p:pic>
        <p:nvPicPr>
          <p:cNvPr id="14" name="Picture 13" descr="A graph of a number of hours&#10;&#10;Description automatically generated">
            <a:extLst>
              <a:ext uri="{FF2B5EF4-FFF2-40B4-BE49-F238E27FC236}">
                <a16:creationId xmlns:a16="http://schemas.microsoft.com/office/drawing/2014/main" id="{A1D5810D-5151-4118-FC9E-40A5F17EBF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720159"/>
            <a:ext cx="5088965" cy="26254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71612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test results&#10;&#10;Description automatically generated">
            <a:extLst>
              <a:ext uri="{FF2B5EF4-FFF2-40B4-BE49-F238E27FC236}">
                <a16:creationId xmlns:a16="http://schemas.microsoft.com/office/drawing/2014/main" id="{65214B25-EC3C-C033-5699-4EE93F114F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2155" y="1283820"/>
            <a:ext cx="4678733" cy="3017520"/>
          </a:xfrm>
          <a:prstGeom prst="rect">
            <a:avLst/>
          </a:prstGeom>
        </p:spPr>
      </p:pic>
      <p:pic>
        <p:nvPicPr>
          <p:cNvPr id="7" name="Picture 6" descr="A close-up of a test results&#10;&#10;Description automatically generated">
            <a:extLst>
              <a:ext uri="{FF2B5EF4-FFF2-40B4-BE49-F238E27FC236}">
                <a16:creationId xmlns:a16="http://schemas.microsoft.com/office/drawing/2014/main" id="{A66343F4-54E6-02B8-8655-2603E068FE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62974" y="1283820"/>
            <a:ext cx="4510509" cy="301752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EC1DDFF-BBE1-056A-7DA5-3BCE2EEDC2AF}"/>
              </a:ext>
            </a:extLst>
          </p:cNvPr>
          <p:cNvSpPr txBox="1"/>
          <p:nvPr/>
        </p:nvSpPr>
        <p:spPr>
          <a:xfrm>
            <a:off x="2122311" y="4749681"/>
            <a:ext cx="880533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2. 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Coimmunoprecipitation of HOS15 and PRR7 in transgenic Arabidopsis plants. </a:t>
            </a:r>
            <a:r>
              <a:rPr lang="en-US" sz="1100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(a,</a:t>
            </a:r>
            <a:r>
              <a:rPr lang="en-US" sz="1100" kern="100" dirty="0"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b) Two additional 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ological trials of Fig. 3B</a:t>
            </a:r>
          </a:p>
          <a:p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696E54F-FC8F-3E5E-1826-112AD1B2519F}"/>
              </a:ext>
            </a:extLst>
          </p:cNvPr>
          <p:cNvSpPr txBox="1"/>
          <p:nvPr/>
        </p:nvSpPr>
        <p:spPr>
          <a:xfrm>
            <a:off x="613186" y="1283820"/>
            <a:ext cx="5613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290563-6547-0960-E416-E2F5E769A729}"/>
              </a:ext>
            </a:extLst>
          </p:cNvPr>
          <p:cNvSpPr txBox="1"/>
          <p:nvPr/>
        </p:nvSpPr>
        <p:spPr>
          <a:xfrm>
            <a:off x="6450228" y="1283820"/>
            <a:ext cx="5774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24829768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test&#10;&#10;Description automatically generated">
            <a:extLst>
              <a:ext uri="{FF2B5EF4-FFF2-40B4-BE49-F238E27FC236}">
                <a16:creationId xmlns:a16="http://schemas.microsoft.com/office/drawing/2014/main" id="{80E10908-717A-074E-3A0F-22526B6682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8164" y="363295"/>
            <a:ext cx="5969000" cy="49911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3C7E449-F099-1852-9635-0BA477617981}"/>
              </a:ext>
            </a:extLst>
          </p:cNvPr>
          <p:cNvSpPr txBox="1"/>
          <p:nvPr/>
        </p:nvSpPr>
        <p:spPr>
          <a:xfrm>
            <a:off x="2619602" y="5606342"/>
            <a:ext cx="811613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3. </a:t>
            </a:r>
            <a:r>
              <a:rPr lang="en-US" sz="1100" b="1" i="1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In vivo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ubiquitination of HOS15 and PRR7 in transgenic Arabidopsis plants.  </a:t>
            </a:r>
            <a:r>
              <a:rPr lang="en-US" sz="1100" kern="100" dirty="0"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Additional 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ological trial of Fig. 4.</a:t>
            </a:r>
          </a:p>
          <a:p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83798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A8706FA9-09AD-AFC0-4AFE-52B97514BE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14461" y="676304"/>
            <a:ext cx="3990416" cy="213312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1FAEF79-FC47-4D7D-B2F3-5E9E8E1DB1A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8160" y="4122361"/>
            <a:ext cx="4686439" cy="716397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9CD4273-F2D9-4C2C-9F68-27FF3620872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8160" y="2960370"/>
            <a:ext cx="4686439" cy="111509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0C4B615-3F3E-4B26-922F-AA8D92D5067B}"/>
              </a:ext>
            </a:extLst>
          </p:cNvPr>
          <p:cNvSpPr txBox="1"/>
          <p:nvPr/>
        </p:nvSpPr>
        <p:spPr>
          <a:xfrm>
            <a:off x="5794599" y="4295893"/>
            <a:ext cx="9132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/>
              <a:t>α</a:t>
            </a:r>
            <a:r>
              <a:rPr lang="en-US" dirty="0"/>
              <a:t>-</a:t>
            </a:r>
            <a:r>
              <a:rPr lang="en-US" dirty="0" err="1"/>
              <a:t>ADK</a:t>
            </a:r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FE57302-DDCC-4EE8-86A3-EFFE8DE32B32}"/>
              </a:ext>
            </a:extLst>
          </p:cNvPr>
          <p:cNvSpPr txBox="1"/>
          <p:nvPr/>
        </p:nvSpPr>
        <p:spPr>
          <a:xfrm>
            <a:off x="5794598" y="3333253"/>
            <a:ext cx="9132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/>
              <a:t>α</a:t>
            </a:r>
            <a:r>
              <a:rPr lang="en-US" dirty="0"/>
              <a:t>-</a:t>
            </a:r>
            <a:r>
              <a:rPr lang="en-US" dirty="0" err="1"/>
              <a:t>GFP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6F179A8-2431-4CFA-B041-B0042DA65010}"/>
              </a:ext>
            </a:extLst>
          </p:cNvPr>
          <p:cNvSpPr txBox="1"/>
          <p:nvPr/>
        </p:nvSpPr>
        <p:spPr>
          <a:xfrm rot="16200000">
            <a:off x="1235308" y="2464737"/>
            <a:ext cx="7192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F7GWT</a:t>
            </a:r>
            <a:endParaRPr lang="en-US" sz="14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9BFB728-3D85-4CE0-BCE5-55FCCB3D2E08}"/>
              </a:ext>
            </a:extLst>
          </p:cNvPr>
          <p:cNvSpPr txBox="1"/>
          <p:nvPr/>
        </p:nvSpPr>
        <p:spPr>
          <a:xfrm rot="16200000">
            <a:off x="1421361" y="2294433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F7Ghos15</a:t>
            </a:r>
            <a:r>
              <a:rPr lang="en-US" sz="1400" dirty="0"/>
              <a:t>-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C19F4E5-0924-433F-A1E2-428B65BC9AA8}"/>
              </a:ext>
            </a:extLst>
          </p:cNvPr>
          <p:cNvSpPr txBox="1"/>
          <p:nvPr/>
        </p:nvSpPr>
        <p:spPr>
          <a:xfrm rot="16200000">
            <a:off x="1948022" y="2464739"/>
            <a:ext cx="7192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F7GWT</a:t>
            </a:r>
            <a:endParaRPr lang="en-US" sz="14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F469640-C23E-4EAD-9475-D28C0B77BEE3}"/>
              </a:ext>
            </a:extLst>
          </p:cNvPr>
          <p:cNvSpPr txBox="1"/>
          <p:nvPr/>
        </p:nvSpPr>
        <p:spPr>
          <a:xfrm rot="16200000">
            <a:off x="2134075" y="2294435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F7Ghos15</a:t>
            </a:r>
            <a:r>
              <a:rPr lang="en-US" sz="1400" dirty="0"/>
              <a:t>-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B4C93BF-17CD-4EFC-A9A0-EFFF7280D87B}"/>
              </a:ext>
            </a:extLst>
          </p:cNvPr>
          <p:cNvSpPr txBox="1"/>
          <p:nvPr/>
        </p:nvSpPr>
        <p:spPr>
          <a:xfrm rot="16200000">
            <a:off x="3855633" y="2464737"/>
            <a:ext cx="7192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F7GWT</a:t>
            </a:r>
            <a:endParaRPr lang="en-US" sz="14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BF89C31-D246-46EE-95DF-3D604D6EE458}"/>
              </a:ext>
            </a:extLst>
          </p:cNvPr>
          <p:cNvSpPr txBox="1"/>
          <p:nvPr/>
        </p:nvSpPr>
        <p:spPr>
          <a:xfrm rot="16200000">
            <a:off x="4041686" y="2294433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F7Ghos15</a:t>
            </a:r>
            <a:r>
              <a:rPr lang="en-US" sz="1400" dirty="0"/>
              <a:t>-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B2B9D7C-5243-4857-8F3B-B1EC2DAD4AC5}"/>
              </a:ext>
            </a:extLst>
          </p:cNvPr>
          <p:cNvSpPr txBox="1"/>
          <p:nvPr/>
        </p:nvSpPr>
        <p:spPr>
          <a:xfrm rot="16200000">
            <a:off x="4664731" y="2464737"/>
            <a:ext cx="7192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F7GWT</a:t>
            </a:r>
            <a:endParaRPr lang="en-US"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B9A0B66-03DE-4E2B-B4D0-7563D3A3737C}"/>
              </a:ext>
            </a:extLst>
          </p:cNvPr>
          <p:cNvSpPr txBox="1"/>
          <p:nvPr/>
        </p:nvSpPr>
        <p:spPr>
          <a:xfrm rot="16200000">
            <a:off x="4850784" y="2294433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F7Ghos15</a:t>
            </a:r>
            <a:r>
              <a:rPr lang="en-US" sz="1400" dirty="0"/>
              <a:t>-2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C2E9B7C9-1DA4-497C-AE50-FB25D4547672}"/>
              </a:ext>
            </a:extLst>
          </p:cNvPr>
          <p:cNvCxnSpPr/>
          <p:nvPr/>
        </p:nvCxnSpPr>
        <p:spPr>
          <a:xfrm>
            <a:off x="1441069" y="1918368"/>
            <a:ext cx="6641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D008B205-0684-4BC5-B833-7B56F1FB5F2A}"/>
              </a:ext>
            </a:extLst>
          </p:cNvPr>
          <p:cNvCxnSpPr/>
          <p:nvPr/>
        </p:nvCxnSpPr>
        <p:spPr>
          <a:xfrm>
            <a:off x="2178072" y="1918368"/>
            <a:ext cx="6641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42265A65-9B3E-40EA-B083-6B0E9F1469F7}"/>
              </a:ext>
            </a:extLst>
          </p:cNvPr>
          <p:cNvCxnSpPr/>
          <p:nvPr/>
        </p:nvCxnSpPr>
        <p:spPr>
          <a:xfrm>
            <a:off x="4109199" y="1918368"/>
            <a:ext cx="6641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E8942C93-500A-4DC0-8603-636B9F62C8FC}"/>
              </a:ext>
            </a:extLst>
          </p:cNvPr>
          <p:cNvCxnSpPr/>
          <p:nvPr/>
        </p:nvCxnSpPr>
        <p:spPr>
          <a:xfrm>
            <a:off x="4846202" y="1918368"/>
            <a:ext cx="6641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2B60C850-1DEF-4DBF-982F-F327CC11277C}"/>
              </a:ext>
            </a:extLst>
          </p:cNvPr>
          <p:cNvSpPr txBox="1"/>
          <p:nvPr/>
        </p:nvSpPr>
        <p:spPr>
          <a:xfrm>
            <a:off x="1585668" y="1525590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0h</a:t>
            </a:r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A9AD501-706F-4C6A-8409-FB0FF26CBA74}"/>
              </a:ext>
            </a:extLst>
          </p:cNvPr>
          <p:cNvSpPr txBox="1"/>
          <p:nvPr/>
        </p:nvSpPr>
        <p:spPr>
          <a:xfrm>
            <a:off x="2290173" y="1525590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4h</a:t>
            </a:r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1E71FA9-68E5-450B-87B2-88AA9D4CC952}"/>
              </a:ext>
            </a:extLst>
          </p:cNvPr>
          <p:cNvSpPr txBox="1"/>
          <p:nvPr/>
        </p:nvSpPr>
        <p:spPr>
          <a:xfrm>
            <a:off x="4262007" y="1538946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0h</a:t>
            </a:r>
            <a:endParaRPr 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C49A8F1-8091-4646-B650-BCDD06FE94B8}"/>
              </a:ext>
            </a:extLst>
          </p:cNvPr>
          <p:cNvSpPr txBox="1"/>
          <p:nvPr/>
        </p:nvSpPr>
        <p:spPr>
          <a:xfrm>
            <a:off x="4966512" y="1538946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5h</a:t>
            </a:r>
            <a:endParaRPr lang="en-US" dirty="0"/>
          </a:p>
        </p:txBody>
      </p:sp>
      <p:grpSp>
        <p:nvGrpSpPr>
          <p:cNvPr id="63" name="Group 62">
            <a:extLst>
              <a:ext uri="{FF2B5EF4-FFF2-40B4-BE49-F238E27FC236}">
                <a16:creationId xmlns:a16="http://schemas.microsoft.com/office/drawing/2014/main" id="{182111CE-B87F-4B9A-8F88-600236F0E8C1}"/>
              </a:ext>
            </a:extLst>
          </p:cNvPr>
          <p:cNvGrpSpPr/>
          <p:nvPr/>
        </p:nvGrpSpPr>
        <p:grpSpPr>
          <a:xfrm>
            <a:off x="898749" y="162625"/>
            <a:ext cx="5849510" cy="1148528"/>
            <a:chOff x="367415" y="165748"/>
            <a:chExt cx="5849510" cy="1148528"/>
          </a:xfrm>
        </p:grpSpPr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DD2DEAE3-2EAD-44AE-9365-76C4DA40E0C9}"/>
                </a:ext>
              </a:extLst>
            </p:cNvPr>
            <p:cNvSpPr/>
            <p:nvPr/>
          </p:nvSpPr>
          <p:spPr>
            <a:xfrm>
              <a:off x="1955347" y="1204465"/>
              <a:ext cx="761999" cy="109811"/>
            </a:xfrm>
            <a:prstGeom prst="rect">
              <a:avLst/>
            </a:prstGeom>
            <a:solidFill>
              <a:schemeClr val="bg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14F0B68B-982D-49AF-96DC-CCBF58D895A3}"/>
                </a:ext>
              </a:extLst>
            </p:cNvPr>
            <p:cNvSpPr/>
            <p:nvPr/>
          </p:nvSpPr>
          <p:spPr>
            <a:xfrm>
              <a:off x="2717346" y="1204465"/>
              <a:ext cx="761999" cy="109811"/>
            </a:xfrm>
            <a:prstGeom prst="rect">
              <a:avLst/>
            </a:prstGeom>
            <a:solidFill>
              <a:schemeClr val="tx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Right Bracket 40">
              <a:extLst>
                <a:ext uri="{FF2B5EF4-FFF2-40B4-BE49-F238E27FC236}">
                  <a16:creationId xmlns:a16="http://schemas.microsoft.com/office/drawing/2014/main" id="{93DEAC2E-7BC9-4648-BAD6-592DE98F5C2E}"/>
                </a:ext>
              </a:extLst>
            </p:cNvPr>
            <p:cNvSpPr/>
            <p:nvPr/>
          </p:nvSpPr>
          <p:spPr>
            <a:xfrm rot="16200000">
              <a:off x="2692154" y="345102"/>
              <a:ext cx="50384" cy="1523999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DE49E4E8-43E8-4ECC-A87D-2DE74F5058A0}"/>
                </a:ext>
              </a:extLst>
            </p:cNvPr>
            <p:cNvSpPr txBox="1"/>
            <p:nvPr/>
          </p:nvSpPr>
          <p:spPr>
            <a:xfrm>
              <a:off x="2189464" y="778614"/>
              <a:ext cx="10320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/>
                <a:t>15°C</a:t>
              </a:r>
              <a:r>
                <a:rPr lang="en-US" sz="1400" dirty="0"/>
                <a:t> for </a:t>
              </a:r>
              <a:r>
                <a:rPr lang="en-US" sz="1400" dirty="0" err="1"/>
                <a:t>1w</a:t>
              </a:r>
              <a:endParaRPr lang="en-US" sz="1400" dirty="0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0A70FDE3-5F91-4720-9088-7C5F7A662368}"/>
                </a:ext>
              </a:extLst>
            </p:cNvPr>
            <p:cNvSpPr/>
            <p:nvPr/>
          </p:nvSpPr>
          <p:spPr>
            <a:xfrm>
              <a:off x="367416" y="1204465"/>
              <a:ext cx="761999" cy="109811"/>
            </a:xfrm>
            <a:prstGeom prst="rect">
              <a:avLst/>
            </a:prstGeom>
            <a:solidFill>
              <a:schemeClr val="bg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BFF520EF-9EFB-45C4-A3F7-C947565B9DA6}"/>
                </a:ext>
              </a:extLst>
            </p:cNvPr>
            <p:cNvSpPr/>
            <p:nvPr/>
          </p:nvSpPr>
          <p:spPr>
            <a:xfrm>
              <a:off x="1129415" y="1204465"/>
              <a:ext cx="761999" cy="109811"/>
            </a:xfrm>
            <a:prstGeom prst="rect">
              <a:avLst/>
            </a:prstGeom>
            <a:solidFill>
              <a:schemeClr val="tx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Right Bracket 44">
              <a:extLst>
                <a:ext uri="{FF2B5EF4-FFF2-40B4-BE49-F238E27FC236}">
                  <a16:creationId xmlns:a16="http://schemas.microsoft.com/office/drawing/2014/main" id="{E6428083-623C-42E3-812E-5DF9CD0DDD19}"/>
                </a:ext>
              </a:extLst>
            </p:cNvPr>
            <p:cNvSpPr/>
            <p:nvPr/>
          </p:nvSpPr>
          <p:spPr>
            <a:xfrm rot="16200000">
              <a:off x="1104223" y="345102"/>
              <a:ext cx="50384" cy="1523999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917B5521-D0CD-4625-90D0-D6B8EEE8C8EA}"/>
                </a:ext>
              </a:extLst>
            </p:cNvPr>
            <p:cNvSpPr txBox="1"/>
            <p:nvPr/>
          </p:nvSpPr>
          <p:spPr>
            <a:xfrm>
              <a:off x="666880" y="762050"/>
              <a:ext cx="10320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22°C for 4w</a:t>
              </a: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70767EED-FB05-46E9-A8D9-2F0A1C701AF5}"/>
                </a:ext>
              </a:extLst>
            </p:cNvPr>
            <p:cNvSpPr/>
            <p:nvPr/>
          </p:nvSpPr>
          <p:spPr>
            <a:xfrm>
              <a:off x="3628065" y="1204464"/>
              <a:ext cx="1871603" cy="109811"/>
            </a:xfrm>
            <a:prstGeom prst="rect">
              <a:avLst/>
            </a:prstGeom>
            <a:solidFill>
              <a:schemeClr val="tx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9" name="Straight Arrow Connector 48">
              <a:extLst>
                <a:ext uri="{FF2B5EF4-FFF2-40B4-BE49-F238E27FC236}">
                  <a16:creationId xmlns:a16="http://schemas.microsoft.com/office/drawing/2014/main" id="{17FCED59-BF16-4445-9036-5577651755B0}"/>
                </a:ext>
              </a:extLst>
            </p:cNvPr>
            <p:cNvCxnSpPr/>
            <p:nvPr/>
          </p:nvCxnSpPr>
          <p:spPr>
            <a:xfrm>
              <a:off x="3628065" y="992936"/>
              <a:ext cx="0" cy="17794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61CB2BF5-9C58-41E7-8197-D45602721369}"/>
                </a:ext>
              </a:extLst>
            </p:cNvPr>
            <p:cNvSpPr txBox="1"/>
            <p:nvPr/>
          </p:nvSpPr>
          <p:spPr>
            <a:xfrm>
              <a:off x="3099477" y="679427"/>
              <a:ext cx="13425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/>
                <a:t>0h</a:t>
              </a:r>
              <a:r>
                <a:rPr lang="en-US" sz="1400" dirty="0"/>
                <a:t> (</a:t>
              </a:r>
              <a:r>
                <a:rPr lang="en-US" sz="1400" dirty="0" err="1"/>
                <a:t>ZT9</a:t>
              </a:r>
              <a:r>
                <a:rPr lang="en-US" sz="1400" dirty="0"/>
                <a:t>) in light</a:t>
              </a:r>
            </a:p>
          </p:txBody>
        </p: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3723A441-9364-478C-84B1-0A75C48AD96F}"/>
                </a:ext>
              </a:extLst>
            </p:cNvPr>
            <p:cNvCxnSpPr/>
            <p:nvPr/>
          </p:nvCxnSpPr>
          <p:spPr>
            <a:xfrm>
              <a:off x="4922495" y="980235"/>
              <a:ext cx="0" cy="17794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FD31D3AA-9BFA-4D9D-80CE-EB9BC8DA82B7}"/>
                </a:ext>
              </a:extLst>
            </p:cNvPr>
            <p:cNvSpPr txBox="1"/>
            <p:nvPr/>
          </p:nvSpPr>
          <p:spPr>
            <a:xfrm>
              <a:off x="4319946" y="685159"/>
              <a:ext cx="9536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/>
                <a:t>4h</a:t>
              </a:r>
              <a:r>
                <a:rPr lang="en-US" sz="1400" dirty="0"/>
                <a:t> (</a:t>
              </a:r>
              <a:r>
                <a:rPr lang="en-US" sz="1400" dirty="0" err="1"/>
                <a:t>ZT13</a:t>
              </a:r>
              <a:r>
                <a:rPr lang="en-US" sz="1400" dirty="0"/>
                <a:t>)</a:t>
              </a:r>
            </a:p>
          </p:txBody>
        </p: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B468B8D6-D342-4CA5-BEB5-F7BF407FD984}"/>
                </a:ext>
              </a:extLst>
            </p:cNvPr>
            <p:cNvCxnSpPr/>
            <p:nvPr/>
          </p:nvCxnSpPr>
          <p:spPr>
            <a:xfrm>
              <a:off x="5506850" y="980235"/>
              <a:ext cx="0" cy="17794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3B9CDCE6-9D43-41CE-89C7-9E6E409971BF}"/>
                </a:ext>
              </a:extLst>
            </p:cNvPr>
            <p:cNvSpPr txBox="1"/>
            <p:nvPr/>
          </p:nvSpPr>
          <p:spPr>
            <a:xfrm>
              <a:off x="5263265" y="687563"/>
              <a:ext cx="9536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/>
                <a:t>5h</a:t>
              </a:r>
              <a:r>
                <a:rPr lang="en-US" sz="1400" dirty="0"/>
                <a:t> (</a:t>
              </a:r>
              <a:r>
                <a:rPr lang="en-US" sz="1400" dirty="0" err="1"/>
                <a:t>ZT14</a:t>
              </a:r>
              <a:r>
                <a:rPr lang="en-US" sz="1400" dirty="0"/>
                <a:t>)</a:t>
              </a:r>
            </a:p>
          </p:txBody>
        </p:sp>
        <p:sp>
          <p:nvSpPr>
            <p:cNvPr id="55" name="Right Bracket 54">
              <a:extLst>
                <a:ext uri="{FF2B5EF4-FFF2-40B4-BE49-F238E27FC236}">
                  <a16:creationId xmlns:a16="http://schemas.microsoft.com/office/drawing/2014/main" id="{E753EE61-5904-4912-AEB0-24AD48E7A99C}"/>
                </a:ext>
              </a:extLst>
            </p:cNvPr>
            <p:cNvSpPr/>
            <p:nvPr/>
          </p:nvSpPr>
          <p:spPr>
            <a:xfrm rot="16200000">
              <a:off x="4540725" y="-257802"/>
              <a:ext cx="50763" cy="1881491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EEEB809-A772-4C93-A891-0C52F3DF3FB0}"/>
                </a:ext>
              </a:extLst>
            </p:cNvPr>
            <p:cNvSpPr txBox="1"/>
            <p:nvPr/>
          </p:nvSpPr>
          <p:spPr>
            <a:xfrm>
              <a:off x="3264472" y="355722"/>
              <a:ext cx="25987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/>
                <a:t>4°C</a:t>
              </a:r>
              <a:r>
                <a:rPr lang="en-US" sz="1400" dirty="0"/>
                <a:t> → </a:t>
              </a:r>
              <a:r>
                <a:rPr lang="en-US" sz="1400" dirty="0" err="1"/>
                <a:t>0°C</a:t>
              </a:r>
              <a:r>
                <a:rPr lang="en-US" sz="1400" dirty="0"/>
                <a:t> → -</a:t>
              </a:r>
              <a:r>
                <a:rPr lang="en-US" sz="1400" dirty="0" err="1"/>
                <a:t>2°C</a:t>
              </a:r>
              <a:r>
                <a:rPr lang="en-US" sz="1400" dirty="0"/>
                <a:t> → -</a:t>
              </a:r>
              <a:r>
                <a:rPr lang="en-US" sz="1400" dirty="0" err="1"/>
                <a:t>4°C</a:t>
              </a:r>
              <a:r>
                <a:rPr lang="en-US" sz="1400" dirty="0"/>
                <a:t> → -</a:t>
              </a:r>
              <a:r>
                <a:rPr lang="en-US" sz="1400" dirty="0" err="1"/>
                <a:t>6°C</a:t>
              </a:r>
              <a:r>
                <a:rPr lang="en-US" sz="1400" dirty="0"/>
                <a:t> 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36C84F52-D635-4046-8BEC-D3627780EA24}"/>
                </a:ext>
              </a:extLst>
            </p:cNvPr>
            <p:cNvSpPr txBox="1"/>
            <p:nvPr/>
          </p:nvSpPr>
          <p:spPr>
            <a:xfrm>
              <a:off x="3264472" y="165748"/>
              <a:ext cx="25555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/>
                <a:t>1hr</a:t>
              </a:r>
              <a:r>
                <a:rPr lang="en-US" sz="1400" dirty="0"/>
                <a:t> → </a:t>
              </a:r>
              <a:r>
                <a:rPr lang="en-US" sz="1400" dirty="0" err="1"/>
                <a:t>1hr</a:t>
              </a:r>
              <a:r>
                <a:rPr lang="en-US" sz="1400" dirty="0"/>
                <a:t> →  </a:t>
              </a:r>
              <a:r>
                <a:rPr lang="en-US" sz="1400" dirty="0" err="1"/>
                <a:t>1hr</a:t>
              </a:r>
              <a:r>
                <a:rPr lang="en-US" sz="1400" dirty="0"/>
                <a:t> →  </a:t>
              </a:r>
              <a:r>
                <a:rPr lang="en-US" sz="1400" dirty="0" err="1"/>
                <a:t>1hr</a:t>
              </a:r>
              <a:r>
                <a:rPr lang="en-US" sz="1400" dirty="0"/>
                <a:t> → </a:t>
              </a:r>
              <a:r>
                <a:rPr lang="en-US" sz="1400" dirty="0" err="1"/>
                <a:t>1hr</a:t>
              </a:r>
              <a:r>
                <a:rPr lang="en-US" sz="1400" dirty="0"/>
                <a:t> </a:t>
              </a:r>
            </a:p>
          </p:txBody>
        </p:sp>
      </p:grpSp>
      <p:pic>
        <p:nvPicPr>
          <p:cNvPr id="10" name="Picture 9">
            <a:extLst>
              <a:ext uri="{FF2B5EF4-FFF2-40B4-BE49-F238E27FC236}">
                <a16:creationId xmlns:a16="http://schemas.microsoft.com/office/drawing/2014/main" id="{1522E378-D6A0-FFBD-80DF-0EE404AE32F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14462" y="2986043"/>
            <a:ext cx="3990416" cy="213805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97D8C03-0FAB-D658-3E52-32051BCA0E9E}"/>
              </a:ext>
            </a:extLst>
          </p:cNvPr>
          <p:cNvSpPr txBox="1"/>
          <p:nvPr/>
        </p:nvSpPr>
        <p:spPr>
          <a:xfrm>
            <a:off x="491280" y="5422084"/>
            <a:ext cx="1152927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4. PRR7 protein abundance is increased in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hos15-2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rosette leaves after freezing stress.</a:t>
            </a:r>
          </a:p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F7G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F7Ghos15-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ere grown on soil in12L/12D at 22°C for four weeks followed by 15°C for one week. For freezing treatment, plant tissue was collected either after -4°C or -6°C treatments after being sequentially exposed to 4°C for 1 h, 0°C for 1 h, -2°C for 1h, and then either -4°C only for 1h, or then -6°C for 1 h (see upper figure). PRR7 protein was detected with anti-GFP and the band intensity was normalized to ADK, with the value of F7G at 0 h set to one.  Two biological trials are shown.</a:t>
            </a: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59256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ollage of different plants&#10;&#10;Description automatically generated">
            <a:extLst>
              <a:ext uri="{FF2B5EF4-FFF2-40B4-BE49-F238E27FC236}">
                <a16:creationId xmlns:a16="http://schemas.microsoft.com/office/drawing/2014/main" id="{1322EAEC-954A-5CAC-9D8F-DE5D685D06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9093" y="590286"/>
            <a:ext cx="9697144" cy="420762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AD0C93E-60E9-D50D-7B74-A9A1E1EF8964}"/>
              </a:ext>
            </a:extLst>
          </p:cNvPr>
          <p:cNvSpPr txBox="1"/>
          <p:nvPr/>
        </p:nvSpPr>
        <p:spPr>
          <a:xfrm>
            <a:off x="1187815" y="4340501"/>
            <a:ext cx="823640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5.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HOS15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s epistatic to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PRR7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n the freezing stress response after no cold acclimation</a:t>
            </a:r>
            <a:endParaRPr lang="en-US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l-0,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hos15-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rr7-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hos15-2prr7-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rr9-1prr7-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ere grown on soil in 12L/12D at 22°C for 24 d and subjected to a gradual temperature decrease starting at ZT9 as follows: 4°C for 1 h, 0°C for 1 h, -2°C for 1 h, and -4°C for 1 h. For the -6°C treatment, the plants were further incubated at -6°C for 1 h. For the -8°C treatment, the -6°C incubation was followed by an additional -8°C for 1 h. All treatments were transferred to 4°C for 16 h for thawing (all above in darkness). The survival rate (100 – yellow plants/green plants) was assessed after incubation at 22°C for 7 d in 12L/12D after the freezing treatments. </a:t>
            </a:r>
          </a:p>
        </p:txBody>
      </p:sp>
    </p:spTree>
    <p:extLst>
      <p:ext uri="{BB962C8B-B14F-4D97-AF65-F5344CB8AC3E}">
        <p14:creationId xmlns:p14="http://schemas.microsoft.com/office/powerpoint/2010/main" val="42440370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624A3E3-FD23-61B2-8FE7-1C8BB9F0BBFB}"/>
              </a:ext>
            </a:extLst>
          </p:cNvPr>
          <p:cNvSpPr txBox="1"/>
          <p:nvPr/>
        </p:nvSpPr>
        <p:spPr>
          <a:xfrm>
            <a:off x="662730" y="4519553"/>
            <a:ext cx="10718861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6. The transcript levels of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CBF1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CBF2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are reduced during freezing stress in the absence of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HOS15 </a:t>
            </a:r>
          </a:p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Col-0, hos15-2, prr7-3, hos15-2prr7-3,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rr9-1prr7-3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ere cultivated on soil in 12L/12D at 22°C for four weeks followed by 15°C for one week. The plants were then exposed to 4°C for 1 h, 0°C for 1 h, -2°C for 1 h, -4°C for 1 h. Rosette leaves were collected both before exposure to 4°C (0 hours after the sequential exposure) and after exposure to -4°C (4 hours after the sequential exposure). Transcript levels of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CBF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CBF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CBF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ere measured using RT-qPCR, with values normalized to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ACTIN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scaled relative to those of Col-0 4 h.</a:t>
            </a:r>
          </a:p>
        </p:txBody>
      </p:sp>
      <p:pic>
        <p:nvPicPr>
          <p:cNvPr id="8" name="Picture 7" descr="A graph of different colored bars&#10;&#10;Description automatically generated with medium confidence">
            <a:extLst>
              <a:ext uri="{FF2B5EF4-FFF2-40B4-BE49-F238E27FC236}">
                <a16:creationId xmlns:a16="http://schemas.microsoft.com/office/drawing/2014/main" id="{2B1B65D1-F81B-3FC7-D1B3-7B2AAB6B99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4324" y="933894"/>
            <a:ext cx="9735671" cy="28091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26294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logo&#10;&#10;Description generated with high confidence">
            <a:extLst>
              <a:ext uri="{FF2B5EF4-FFF2-40B4-BE49-F238E27FC236}">
                <a16:creationId xmlns:a16="http://schemas.microsoft.com/office/drawing/2014/main" id="{2DC0D2D8-EAA0-25D5-3939-889D8FF8E2B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4" t="-3176" r="48194" b="550"/>
          <a:stretch/>
        </p:blipFill>
        <p:spPr>
          <a:xfrm>
            <a:off x="4944023" y="2870717"/>
            <a:ext cx="1005103" cy="649850"/>
          </a:xfrm>
          <a:prstGeom prst="rect">
            <a:avLst/>
          </a:prstGeom>
        </p:spPr>
      </p:pic>
      <p:pic>
        <p:nvPicPr>
          <p:cNvPr id="4" name="Picture 3" descr="A close up of a logo&#10;&#10;Description generated with high confidence">
            <a:extLst>
              <a:ext uri="{FF2B5EF4-FFF2-40B4-BE49-F238E27FC236}">
                <a16:creationId xmlns:a16="http://schemas.microsoft.com/office/drawing/2014/main" id="{C7E78833-F5EF-AD99-AFA0-AA0552CCFB5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28" t="7891" r="44914" b="3511"/>
          <a:stretch/>
        </p:blipFill>
        <p:spPr>
          <a:xfrm>
            <a:off x="5949126" y="2891361"/>
            <a:ext cx="960136" cy="6292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27C43E3-6E4B-C271-7966-A21AEE84DE4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287" r="73693"/>
          <a:stretch/>
        </p:blipFill>
        <p:spPr>
          <a:xfrm>
            <a:off x="4946570" y="3564899"/>
            <a:ext cx="994767" cy="70421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419A757-FC88-E0B7-C401-19AE7FE66E40}"/>
              </a:ext>
            </a:extLst>
          </p:cNvPr>
          <p:cNvSpPr txBox="1"/>
          <p:nvPr/>
        </p:nvSpPr>
        <p:spPr>
          <a:xfrm>
            <a:off x="4143313" y="3674078"/>
            <a:ext cx="765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</a:t>
            </a:r>
            <a:r>
              <a:rPr lang="en-US" dirty="0" err="1"/>
              <a:t>myc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C4F133E-6F50-ADD1-4804-8CC50BFF7AB0}"/>
              </a:ext>
            </a:extLst>
          </p:cNvPr>
          <p:cNvSpPr txBox="1"/>
          <p:nvPr/>
        </p:nvSpPr>
        <p:spPr>
          <a:xfrm>
            <a:off x="4152097" y="3026628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GF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4B18436-E3CD-8AD3-91F3-86FC0F0C9514}"/>
              </a:ext>
            </a:extLst>
          </p:cNvPr>
          <p:cNvSpPr txBox="1"/>
          <p:nvPr/>
        </p:nvSpPr>
        <p:spPr>
          <a:xfrm rot="16200000">
            <a:off x="4845776" y="2272056"/>
            <a:ext cx="930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yc-COP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E501AD6-67C3-5A4A-529F-9E5A8CCC0865}"/>
              </a:ext>
            </a:extLst>
          </p:cNvPr>
          <p:cNvSpPr txBox="1"/>
          <p:nvPr/>
        </p:nvSpPr>
        <p:spPr>
          <a:xfrm rot="16200000">
            <a:off x="4863903" y="1896831"/>
            <a:ext cx="17227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yc-COP1/GFP-PRR7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43BD7BE5-7924-6F71-C8D9-7694C74D1BA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12" t="8287" r="22397"/>
          <a:stretch/>
        </p:blipFill>
        <p:spPr>
          <a:xfrm>
            <a:off x="5941337" y="3564900"/>
            <a:ext cx="960137" cy="70421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A9AAE63-7DED-93BC-CA8C-9E36B91323AF}"/>
              </a:ext>
            </a:extLst>
          </p:cNvPr>
          <p:cNvSpPr txBox="1"/>
          <p:nvPr/>
        </p:nvSpPr>
        <p:spPr>
          <a:xfrm rot="16200000">
            <a:off x="5776304" y="2272056"/>
            <a:ext cx="930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yc-COP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1CE30B7-A1A4-12AE-DEAB-71BDB746FE84}"/>
              </a:ext>
            </a:extLst>
          </p:cNvPr>
          <p:cNvSpPr txBox="1"/>
          <p:nvPr/>
        </p:nvSpPr>
        <p:spPr>
          <a:xfrm rot="16200000">
            <a:off x="5794431" y="1896831"/>
            <a:ext cx="17227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yc-COP1/GFP-PRR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C7CDD2C-F97C-3900-06D2-114E2CD7D63D}"/>
              </a:ext>
            </a:extLst>
          </p:cNvPr>
          <p:cNvSpPr txBox="1"/>
          <p:nvPr/>
        </p:nvSpPr>
        <p:spPr>
          <a:xfrm>
            <a:off x="2019300" y="4581525"/>
            <a:ext cx="823640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7. PRR7 interacts with COP1 in N.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immunoprecipitation of PRR7 and COP1 was performed using the transient expression in 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GFP-PRR7 and myc-COP1 were co-expressed in three-week-ol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eaves by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Agrobacterium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filtration, and total proteins were immunoprecipitated with anti-GFP followed by detection with anti-GFP and anti-myc. Representative of three independent experiments.</a:t>
            </a: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73509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19</TotalTime>
  <Words>843</Words>
  <Application>Microsoft Office PowerPoint</Application>
  <PresentationFormat>Widescreen</PresentationFormat>
  <Paragraphs>41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m, Yeon Jeong</dc:creator>
  <cp:lastModifiedBy>Somers, David</cp:lastModifiedBy>
  <cp:revision>268</cp:revision>
  <cp:lastPrinted>2024-07-01T22:44:46Z</cp:lastPrinted>
  <dcterms:created xsi:type="dcterms:W3CDTF">2023-07-24T19:49:32Z</dcterms:created>
  <dcterms:modified xsi:type="dcterms:W3CDTF">2024-07-01T23:08:16Z</dcterms:modified>
</cp:coreProperties>
</file>